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9DA191-31AF-4CEA-8BF5-970BAF8ECF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3FDF47-F0C7-4DEE-B4AA-04CC187937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BA778C-2838-4370-A9B6-D8CA74626C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150F9-76E8-4EC0-92AB-F9D7E1CA76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F2D93-CA25-4E7A-85F2-4AFA718D2F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77463C-60F6-40A4-9789-B5AB95F000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682615-C728-4ADB-96EC-FF5B9AB476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4E902-3229-4466-8719-C82334E3C5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6BE0F-4DCB-4023-BA58-E9E13B0ADC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F8F73-1C06-4CE8-8E30-5F3FDE397C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BC9E49-D62F-41B2-B221-122ED9D32C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321077-C0EA-4082-A93B-768A6DBA3F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67B119-223B-49DF-B111-2E7DAAA64F4A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圖片 2" descr=".eps"/>
          <p:cNvPicPr/>
          <p:nvPr/>
        </p:nvPicPr>
        <p:blipFill>
          <a:blip r:embed="rId1"/>
          <a:stretch/>
        </p:blipFill>
        <p:spPr>
          <a:xfrm>
            <a:off x="1536840" y="907920"/>
            <a:ext cx="5954400" cy="3264120"/>
          </a:xfrm>
          <a:prstGeom prst="rect">
            <a:avLst/>
          </a:prstGeom>
          <a:ln w="0">
            <a:noFill/>
          </a:ln>
        </p:spPr>
      </p:pic>
      <p:grpSp>
        <p:nvGrpSpPr>
          <p:cNvPr id="42" name="群組 14"/>
          <p:cNvGrpSpPr/>
          <p:nvPr/>
        </p:nvGrpSpPr>
        <p:grpSpPr>
          <a:xfrm>
            <a:off x="2652840" y="1766880"/>
            <a:ext cx="4440240" cy="103320"/>
            <a:chOff x="2652840" y="1766880"/>
            <a:chExt cx="4440240" cy="103320"/>
          </a:xfrm>
        </p:grpSpPr>
        <p:sp>
          <p:nvSpPr>
            <p:cNvPr id="43" name="直線接點 13"/>
            <p:cNvSpPr/>
            <p:nvPr/>
          </p:nvSpPr>
          <p:spPr>
            <a:xfrm>
              <a:off x="2652840" y="1819440"/>
              <a:ext cx="4440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矩形 2"/>
            <p:cNvSpPr/>
            <p:nvPr/>
          </p:nvSpPr>
          <p:spPr>
            <a:xfrm>
              <a:off x="2876400" y="1782720"/>
              <a:ext cx="485640" cy="651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矩形 3"/>
            <p:cNvSpPr/>
            <p:nvPr/>
          </p:nvSpPr>
          <p:spPr>
            <a:xfrm>
              <a:off x="3733920" y="1782720"/>
              <a:ext cx="874440" cy="651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向右箭號 4"/>
            <p:cNvSpPr/>
            <p:nvPr/>
          </p:nvSpPr>
          <p:spPr>
            <a:xfrm>
              <a:off x="5362920" y="1766880"/>
              <a:ext cx="193680" cy="97200"/>
            </a:xfrm>
            <a:prstGeom prst="rightArrow">
              <a:avLst>
                <a:gd name="adj1" fmla="val 50000"/>
                <a:gd name="adj2" fmla="val 49676"/>
              </a:avLst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向右箭號 5"/>
            <p:cNvSpPr/>
            <p:nvPr/>
          </p:nvSpPr>
          <p:spPr>
            <a:xfrm>
              <a:off x="5686560" y="1773000"/>
              <a:ext cx="582480" cy="97200"/>
            </a:xfrm>
            <a:prstGeom prst="rightArrow">
              <a:avLst>
                <a:gd name="adj1" fmla="val 50000"/>
                <a:gd name="adj2" fmla="val 49661"/>
              </a:avLst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向右箭號 6"/>
            <p:cNvSpPr/>
            <p:nvPr/>
          </p:nvSpPr>
          <p:spPr>
            <a:xfrm>
              <a:off x="6370920" y="1766880"/>
              <a:ext cx="422280" cy="97200"/>
            </a:xfrm>
            <a:prstGeom prst="rightArrow">
              <a:avLst>
                <a:gd name="adj1" fmla="val 50000"/>
                <a:gd name="adj2" fmla="val 49679"/>
              </a:avLst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群組 15"/>
          <p:cNvGrpSpPr/>
          <p:nvPr/>
        </p:nvGrpSpPr>
        <p:grpSpPr>
          <a:xfrm>
            <a:off x="2673360" y="2930400"/>
            <a:ext cx="4438800" cy="63720"/>
            <a:chOff x="2673360" y="2930400"/>
            <a:chExt cx="4438800" cy="63720"/>
          </a:xfrm>
        </p:grpSpPr>
        <p:sp>
          <p:nvSpPr>
            <p:cNvPr id="50" name="直線接點 10"/>
            <p:cNvSpPr/>
            <p:nvPr/>
          </p:nvSpPr>
          <p:spPr>
            <a:xfrm>
              <a:off x="2673360" y="2967840"/>
              <a:ext cx="4438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矩形 11"/>
            <p:cNvSpPr/>
            <p:nvPr/>
          </p:nvSpPr>
          <p:spPr>
            <a:xfrm>
              <a:off x="2673360" y="2930400"/>
              <a:ext cx="582480" cy="6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矩形 12"/>
            <p:cNvSpPr/>
            <p:nvPr/>
          </p:nvSpPr>
          <p:spPr>
            <a:xfrm>
              <a:off x="5758200" y="2930400"/>
              <a:ext cx="1038240" cy="6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群組 16"/>
          <p:cNvGrpSpPr/>
          <p:nvPr/>
        </p:nvGrpSpPr>
        <p:grpSpPr>
          <a:xfrm>
            <a:off x="2600280" y="4125960"/>
            <a:ext cx="2739960" cy="68040"/>
            <a:chOff x="2600280" y="4125960"/>
            <a:chExt cx="2739960" cy="68040"/>
          </a:xfrm>
        </p:grpSpPr>
        <p:sp>
          <p:nvSpPr>
            <p:cNvPr id="54" name="直線接點 7"/>
            <p:cNvSpPr/>
            <p:nvPr/>
          </p:nvSpPr>
          <p:spPr>
            <a:xfrm>
              <a:off x="2600280" y="4162320"/>
              <a:ext cx="2689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矩形 8"/>
            <p:cNvSpPr/>
            <p:nvPr/>
          </p:nvSpPr>
          <p:spPr>
            <a:xfrm>
              <a:off x="2764800" y="4128840"/>
              <a:ext cx="879480" cy="651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矩形 9"/>
            <p:cNvSpPr/>
            <p:nvPr/>
          </p:nvSpPr>
          <p:spPr>
            <a:xfrm>
              <a:off x="4726440" y="4125960"/>
              <a:ext cx="613800" cy="651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" name="文字方塊 20"/>
          <p:cNvSpPr/>
          <p:nvPr/>
        </p:nvSpPr>
        <p:spPr>
          <a:xfrm>
            <a:off x="2976120" y="1787400"/>
            <a:ext cx="27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字方塊 21"/>
          <p:cNvSpPr/>
          <p:nvPr/>
        </p:nvSpPr>
        <p:spPr>
          <a:xfrm>
            <a:off x="5315760" y="181620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文字方塊 22"/>
          <p:cNvSpPr/>
          <p:nvPr/>
        </p:nvSpPr>
        <p:spPr>
          <a:xfrm>
            <a:off x="4008240" y="1789200"/>
            <a:ext cx="27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文字方塊 27"/>
          <p:cNvSpPr/>
          <p:nvPr/>
        </p:nvSpPr>
        <p:spPr>
          <a:xfrm>
            <a:off x="5829480" y="181620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文字方塊 28"/>
          <p:cNvSpPr/>
          <p:nvPr/>
        </p:nvSpPr>
        <p:spPr>
          <a:xfrm>
            <a:off x="6431760" y="181620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文字方塊 23"/>
          <p:cNvSpPr/>
          <p:nvPr/>
        </p:nvSpPr>
        <p:spPr>
          <a:xfrm>
            <a:off x="2825280" y="2924280"/>
            <a:ext cx="27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文字方塊 24"/>
          <p:cNvSpPr/>
          <p:nvPr/>
        </p:nvSpPr>
        <p:spPr>
          <a:xfrm>
            <a:off x="6152760" y="2924280"/>
            <a:ext cx="27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文字方塊 25"/>
          <p:cNvSpPr/>
          <p:nvPr/>
        </p:nvSpPr>
        <p:spPr>
          <a:xfrm>
            <a:off x="3061800" y="4154400"/>
            <a:ext cx="27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文字方塊 26"/>
          <p:cNvSpPr/>
          <p:nvPr/>
        </p:nvSpPr>
        <p:spPr>
          <a:xfrm>
            <a:off x="4905000" y="4154400"/>
            <a:ext cx="27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600200" y="5334120"/>
            <a:ext cx="27748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371600" y="4800600"/>
            <a:ext cx="64008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200" spc="-1" strike="noStrike">
                <a:solidFill>
                  <a:srgbClr val="000000"/>
                </a:solidFill>
                <a:latin typeface="Times New Roman"/>
              </a:rPr>
              <a:t>Figure S3  Comparison of tyrosine integrase of Smp131 and its homologues. 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Identical residues found in more than 3 residues are highlighted.  Active sites determined for XerD are indicated by downward arrowhead and the RKHRH pentad conserved residues are indicated above.  The α-helix (empty rectangle) and β-sheet (empty arrow) structural motifs under the alignments are based on the crystal structure of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E. coli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XerD.  Abbreviations: Smp131, integrase deduced from Smp131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orf43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; P2, integrase of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Enterobacteria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phage P2 (GenBank:P36932); 186, integrase of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Enterobacteria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phage 186 (GenBank:P06723); XerD, site-specific recombinase of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E. coli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(GenBank:1A0P_A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user</cp:lastModifiedBy>
  <dcterms:modified xsi:type="dcterms:W3CDTF">2014-01-12T09:54:01Z</dcterms:modified>
  <cp:revision>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